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media/image1.pct" ContentType="image/x-pict"/>
  <Override PartName="/ppt/media/image2.png" ContentType="image/png"/>
  <Override PartName="/ppt/media/image3.pct" ContentType="image/x-pict"/>
  <Override PartName="/ppt/media/image4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20875625" cy="104441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D1942-D6CB-4231-95B7-C868B37C05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1565280" y="3016080"/>
            <a:ext cx="1774512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1565280" y="6289200"/>
            <a:ext cx="1774512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F12B0-E054-4429-A737-8A687C1E341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1565280" y="301608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10658160" y="301608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1565280" y="628920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10658160" y="628920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FCCF7-E24F-49FE-9F5B-2ECAFD7577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1565280" y="3016080"/>
            <a:ext cx="571356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7565040" y="3016080"/>
            <a:ext cx="571356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3564440" y="3016080"/>
            <a:ext cx="571356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1565280" y="6289200"/>
            <a:ext cx="571356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7565040" y="6289200"/>
            <a:ext cx="571356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3564440" y="6289200"/>
            <a:ext cx="571356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A025B-7758-454D-83BF-C6DFB7CB4B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1565280" y="3016080"/>
            <a:ext cx="17745120" cy="6266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51"/>
              </a:spcBef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3661BA-E6EA-4EEA-A76F-8339C73615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1565280" y="3016080"/>
            <a:ext cx="17745120" cy="626616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CB50C-3862-4042-A09B-BBC5043F9A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1565280" y="3016080"/>
            <a:ext cx="8659440" cy="626616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10658160" y="3016080"/>
            <a:ext cx="8659440" cy="626616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FF01C-9C73-451B-83DC-5A36492A08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C1651-FAD3-4791-8220-4F3C1CBAC8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565280" y="928440"/>
            <a:ext cx="17745120" cy="8066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51"/>
              </a:spcBef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6B4F41-08C9-46A6-92E2-EA92104097C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1565280" y="301608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10658160" y="3016080"/>
            <a:ext cx="8659440" cy="626616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1565280" y="628920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AC71D-9C6F-4A47-A0AB-6EA961107C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1565280" y="3016080"/>
            <a:ext cx="8659440" cy="626616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10658160" y="301608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10658160" y="628920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F23083-3D3C-4F38-A600-491C35A621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1565280" y="301608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10658160" y="3016080"/>
            <a:ext cx="865944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1565280" y="6289200"/>
            <a:ext cx="17745120" cy="298872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/>
          </a:bodyPr>
          <a:p>
            <a:pPr indent="0">
              <a:spcBef>
                <a:spcPts val="1551"/>
              </a:spcBef>
              <a:buNone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6D653-1E21-4C43-8327-43650AEAFB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565280" y="928440"/>
            <a:ext cx="17745120" cy="173988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ctr">
            <a:noAutofit/>
          </a:bodyPr>
          <a:p>
            <a:pPr indent="0" algn="ctr">
              <a:buNone/>
              <a:tabLst>
                <a:tab algn="l" pos="0"/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r>
              <a:rPr b="0" lang="en-US" sz="8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1565280" y="3016080"/>
            <a:ext cx="17745120" cy="626616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rmAutofit fontScale="78000"/>
          </a:bodyPr>
          <a:p>
            <a:pPr marL="523440" indent="-52344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  <a:p>
            <a:pPr lvl="1" marL="1134000" indent="-43560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  <a:p>
            <a:pPr lvl="2" marL="1744560" indent="-348840">
              <a:spcBef>
                <a:spcPts val="1551"/>
              </a:spcBef>
              <a:buClr>
                <a:srgbClr val="000000"/>
              </a:buClr>
              <a:buFont typeface="Arial"/>
              <a:buChar char="•"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  <a:p>
            <a:pPr lvl="3" marL="2442960" indent="-348840">
              <a:spcBef>
                <a:spcPts val="1551"/>
              </a:spcBef>
              <a:buClr>
                <a:srgbClr val="000000"/>
              </a:buClr>
              <a:buFont typeface="Arial"/>
              <a:buChar char="–"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  <a:p>
            <a:pPr lvl="4" marL="3139920" indent="-34776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  <a:p>
            <a:pPr lvl="5" marL="3139920" indent="-34776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  <a:p>
            <a:pPr lvl="6" marL="3139920" indent="-347760">
              <a:spcBef>
                <a:spcPts val="1551"/>
              </a:spcBef>
              <a:buClr>
                <a:srgbClr val="000000"/>
              </a:buClr>
              <a:buFont typeface="Arial"/>
              <a:buChar char="»"/>
              <a:tabLst>
                <a:tab algn="l" pos="1789200"/>
                <a:tab algn="l" pos="3578400"/>
                <a:tab algn="l" pos="5367240"/>
                <a:tab algn="l" pos="7156440"/>
                <a:tab algn="l" pos="8945640"/>
                <a:tab algn="l" pos="10734840"/>
              </a:tabLst>
            </a:pPr>
            <a:r>
              <a:rPr b="0" lang="en-US" sz="6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1564920" y="9513720"/>
            <a:ext cx="4349880" cy="69696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7132680" y="9513720"/>
            <a:ext cx="6610320" cy="69696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4960160" y="9513720"/>
            <a:ext cx="4349880" cy="696960"/>
          </a:xfrm>
          <a:prstGeom prst="rect">
            <a:avLst/>
          </a:prstGeom>
          <a:noFill/>
          <a:ln w="0">
            <a:noFill/>
          </a:ln>
        </p:spPr>
        <p:txBody>
          <a:bodyPr lIns="178920" rIns="178920" tIns="89640" bIns="89640" anchor="t">
            <a:noAutofit/>
          </a:bodyPr>
          <a:lstStyle>
            <a:lvl1pPr indent="0" algn="r">
              <a:buNone/>
              <a:tabLst>
                <a:tab algn="l" pos="0"/>
                <a:tab algn="l" pos="779400"/>
                <a:tab algn="l" pos="1558800"/>
                <a:tab algn="l" pos="2338560"/>
                <a:tab algn="l" pos="3117960"/>
                <a:tab algn="l" pos="3897360"/>
                <a:tab algn="l" pos="4676760"/>
                <a:tab algn="l" pos="5456160"/>
                <a:tab algn="l" pos="6235560"/>
                <a:tab algn="l" pos="7015320"/>
                <a:tab algn="l" pos="7794720"/>
                <a:tab algn="l" pos="8574120"/>
                <a:tab algn="l" pos="9353520"/>
                <a:tab algn="l" pos="10132920"/>
                <a:tab algn="l" pos="10912320"/>
              </a:tabLst>
              <a:defRPr b="0" lang="fr-FR" sz="27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779400"/>
                <a:tab algn="l" pos="1558800"/>
                <a:tab algn="l" pos="2338560"/>
                <a:tab algn="l" pos="3117960"/>
                <a:tab algn="l" pos="3897360"/>
                <a:tab algn="l" pos="4676760"/>
                <a:tab algn="l" pos="5456160"/>
                <a:tab algn="l" pos="6235560"/>
                <a:tab algn="l" pos="7015320"/>
                <a:tab algn="l" pos="7794720"/>
                <a:tab algn="l" pos="8574120"/>
                <a:tab algn="l" pos="9353520"/>
                <a:tab algn="l" pos="10132920"/>
                <a:tab algn="l" pos="10912320"/>
              </a:tabLst>
            </a:pPr>
            <a:fld id="{EA6CEEE1-B1AC-41E7-9E22-BFC2EABB0DD7}" type="slidenum">
              <a:rPr b="0" lang="fr-FR" sz="27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image" Target="../media/image2.png"/><Relationship Id="rId4" Type="http://schemas.openxmlformats.org/officeDocument/2006/relationships/package" Target="../embeddings/oleObject2.xlsx"/><Relationship Id="rId5" Type="http://schemas.openxmlformats.org/officeDocument/2006/relationships/image" Target="../media/image3.pct"/><Relationship Id="rId6" Type="http://schemas.openxmlformats.org/officeDocument/2006/relationships/package" Target="../embeddings/oleObject3.xlsx"/><Relationship Id="rId7" Type="http://schemas.openxmlformats.org/officeDocument/2006/relationships/image" Target="../media/image4.pct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7"/>
          <p:cNvSpPr/>
          <p:nvPr/>
        </p:nvSpPr>
        <p:spPr>
          <a:xfrm>
            <a:off x="18996120" y="4807080"/>
            <a:ext cx="511200" cy="1617480"/>
          </a:xfrm>
          <a:prstGeom prst="rect">
            <a:avLst/>
          </a:prstGeom>
          <a:solidFill>
            <a:srgbClr val="dcdc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68"/>
          <p:cNvSpPr/>
          <p:nvPr/>
        </p:nvSpPr>
        <p:spPr>
          <a:xfrm>
            <a:off x="14824080" y="4805280"/>
            <a:ext cx="511200" cy="1617840"/>
          </a:xfrm>
          <a:prstGeom prst="rect">
            <a:avLst/>
          </a:prstGeom>
          <a:solidFill>
            <a:srgbClr val="dcdc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6"/>
          <p:cNvSpPr/>
          <p:nvPr/>
        </p:nvSpPr>
        <p:spPr>
          <a:xfrm>
            <a:off x="17402040" y="7864560"/>
            <a:ext cx="511200" cy="1617480"/>
          </a:xfrm>
          <a:prstGeom prst="rect">
            <a:avLst/>
          </a:prstGeom>
          <a:solidFill>
            <a:srgbClr val="dcdc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65"/>
          <p:cNvSpPr/>
          <p:nvPr/>
        </p:nvSpPr>
        <p:spPr>
          <a:xfrm>
            <a:off x="16043400" y="7864560"/>
            <a:ext cx="511200" cy="1617480"/>
          </a:xfrm>
          <a:prstGeom prst="rect">
            <a:avLst/>
          </a:prstGeom>
          <a:solidFill>
            <a:srgbClr val="dcdc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12219120" y="7304040"/>
          <a:ext cx="8507160" cy="21477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2219120" y="7304040"/>
                    <a:ext cx="8507160" cy="21477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47" name="Picture 55" descr="segm_theo_log"/>
          <p:cNvPicPr/>
          <p:nvPr/>
        </p:nvPicPr>
        <p:blipFill>
          <a:blip r:embed="rId3"/>
          <a:stretch/>
        </p:blipFill>
        <p:spPr>
          <a:xfrm>
            <a:off x="1692360" y="777960"/>
            <a:ext cx="9356760" cy="9356760"/>
          </a:xfrm>
          <a:prstGeom prst="rect">
            <a:avLst/>
          </a:prstGeom>
          <a:ln w="0">
            <a:noFill/>
          </a:ln>
        </p:spPr>
      </p:pic>
      <p:sp>
        <p:nvSpPr>
          <p:cNvPr id="48" name="Text Box 24"/>
          <p:cNvSpPr/>
          <p:nvPr/>
        </p:nvSpPr>
        <p:spPr>
          <a:xfrm>
            <a:off x="2525760" y="777960"/>
            <a:ext cx="4521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5"/>
          <p:cNvSpPr/>
          <p:nvPr/>
        </p:nvSpPr>
        <p:spPr>
          <a:xfrm>
            <a:off x="3745080" y="777960"/>
            <a:ext cx="4521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26"/>
          <p:cNvSpPr/>
          <p:nvPr/>
        </p:nvSpPr>
        <p:spPr>
          <a:xfrm>
            <a:off x="5344920" y="777960"/>
            <a:ext cx="47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27"/>
          <p:cNvSpPr/>
          <p:nvPr/>
        </p:nvSpPr>
        <p:spPr>
          <a:xfrm>
            <a:off x="7478640" y="777960"/>
            <a:ext cx="47484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28"/>
          <p:cNvSpPr/>
          <p:nvPr/>
        </p:nvSpPr>
        <p:spPr>
          <a:xfrm>
            <a:off x="9536040" y="777960"/>
            <a:ext cx="4521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34"/>
          <p:cNvSpPr/>
          <p:nvPr/>
        </p:nvSpPr>
        <p:spPr>
          <a:xfrm>
            <a:off x="459360" y="2378160"/>
            <a:ext cx="16923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000000"/>
                </a:solidFill>
                <a:latin typeface="Arial"/>
              </a:rPr>
              <a:t>Tumor 1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35"/>
          <p:cNvSpPr/>
          <p:nvPr/>
        </p:nvSpPr>
        <p:spPr>
          <a:xfrm>
            <a:off x="459360" y="5538960"/>
            <a:ext cx="16923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000000"/>
                </a:solidFill>
                <a:latin typeface="Arial"/>
              </a:rPr>
              <a:t>Tumor 2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36"/>
          <p:cNvSpPr/>
          <p:nvPr/>
        </p:nvSpPr>
        <p:spPr>
          <a:xfrm>
            <a:off x="459360" y="8632800"/>
            <a:ext cx="169236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3200" spc="-1" strike="noStrike">
                <a:solidFill>
                  <a:srgbClr val="000000"/>
                </a:solidFill>
                <a:latin typeface="Arial"/>
              </a:rPr>
              <a:t>Tumor 3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1"/>
          <p:cNvSpPr/>
          <p:nvPr/>
        </p:nvSpPr>
        <p:spPr>
          <a:xfrm>
            <a:off x="12219840" y="930240"/>
            <a:ext cx="2315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2400" spc="-1" strike="noStrike">
                <a:solidFill>
                  <a:srgbClr val="000000"/>
                </a:solidFill>
                <a:latin typeface="Arial"/>
              </a:rPr>
              <a:t>Segment matri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42"/>
          <p:cNvSpPr/>
          <p:nvPr/>
        </p:nvSpPr>
        <p:spPr>
          <a:xfrm>
            <a:off x="12220920" y="3825720"/>
            <a:ext cx="2552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2400" spc="-1" strike="noStrike">
                <a:solidFill>
                  <a:srgbClr val="000000"/>
                </a:solidFill>
                <a:latin typeface="Arial"/>
              </a:rPr>
              <a:t>Breakpoint matri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44"/>
          <p:cNvSpPr/>
          <p:nvPr/>
        </p:nvSpPr>
        <p:spPr>
          <a:xfrm>
            <a:off x="12221280" y="6797520"/>
            <a:ext cx="2449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2400" spc="-1" strike="noStrike">
                <a:solidFill>
                  <a:srgbClr val="000000"/>
                </a:solidFill>
                <a:latin typeface="Arial"/>
              </a:rPr>
              <a:t>Amplitude matrix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9" name=""/>
          <p:cNvGraphicFramePr/>
          <p:nvPr/>
        </p:nvGraphicFramePr>
        <p:xfrm>
          <a:off x="13498560" y="1373040"/>
          <a:ext cx="5769000" cy="2148120"/>
        </p:xfrm>
        <a:graphic>
          <a:graphicData uri="http://schemas.openxmlformats.org/presentationml/2006/ole">
            <p:oleObj progId="Excel.Sheet.12" r:id="rId4" spid="">
              <p:embed/>
              <p:pic>
                <p:nvPicPr>
                  <p:cNvPr id="60" name="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13498560" y="1373040"/>
                    <a:ext cx="5769000" cy="2148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1" name=""/>
          <p:cNvGraphicFramePr/>
          <p:nvPr/>
        </p:nvGraphicFramePr>
        <p:xfrm>
          <a:off x="12980880" y="4282920"/>
          <a:ext cx="6816960" cy="2148120"/>
        </p:xfrm>
        <a:graphic>
          <a:graphicData uri="http://schemas.openxmlformats.org/presentationml/2006/ole">
            <p:oleObj progId="Excel.Sheet.12" r:id="rId6" spid="">
              <p:embed/>
              <p:pic>
                <p:nvPicPr>
                  <p:cNvPr id="62" name="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12980880" y="4282920"/>
                    <a:ext cx="6816960" cy="2148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3" name="Line 60"/>
          <p:cNvSpPr/>
          <p:nvPr/>
        </p:nvSpPr>
        <p:spPr>
          <a:xfrm>
            <a:off x="12766680" y="9540720"/>
            <a:ext cx="372420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61"/>
          <p:cNvSpPr/>
          <p:nvPr/>
        </p:nvSpPr>
        <p:spPr>
          <a:xfrm>
            <a:off x="13455360" y="9617040"/>
            <a:ext cx="23464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2400" spc="-1" strike="noStrike">
                <a:solidFill>
                  <a:srgbClr val="ff0000"/>
                </a:solidFill>
                <a:latin typeface="Arial"/>
              </a:rPr>
              <a:t>Breakpoints ‘up’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62"/>
          <p:cNvSpPr/>
          <p:nvPr/>
        </p:nvSpPr>
        <p:spPr>
          <a:xfrm>
            <a:off x="16814880" y="9540720"/>
            <a:ext cx="3724200" cy="0"/>
          </a:xfrm>
          <a:prstGeom prst="line">
            <a:avLst/>
          </a:prstGeom>
          <a:ln w="28440">
            <a:solidFill>
              <a:srgbClr val="00a40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63"/>
          <p:cNvSpPr/>
          <p:nvPr/>
        </p:nvSpPr>
        <p:spPr>
          <a:xfrm>
            <a:off x="17309160" y="9617040"/>
            <a:ext cx="2734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2400" spc="-1" strike="noStrike">
                <a:solidFill>
                  <a:srgbClr val="00a402"/>
                </a:solidFill>
                <a:latin typeface="Arial"/>
              </a:rPr>
              <a:t>Breakpoints ‘down’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5280" y="0"/>
            <a:ext cx="80100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1280240" y="0"/>
            <a:ext cx="82836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1T08:10:24Z</dcterms:created>
  <dc:creator>Utilisateur de la version d'évaluation de Office 2004</dc:creator>
  <dc:description/>
  <dc:language>en-US</dc:language>
  <cp:lastModifiedBy>Utilisateur de la version d'évaluation de Office 2004</cp:lastModifiedBy>
  <cp:lastPrinted>2009-10-11T19:43:01Z</cp:lastPrinted>
  <dcterms:modified xsi:type="dcterms:W3CDTF">2010-08-09T08:38:04Z</dcterms:modified>
  <cp:revision>12</cp:revision>
  <dc:subject/>
  <dc:title>Présentation PowerPoint</dc:title>
</cp:coreProperties>
</file>